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A1CFD-5EFD-7226-5035-BB90113E2E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CF4A02-ECBB-1946-4537-73D3D95B8F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59BDF-F6C9-0B49-B411-8F5F444CB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64887E-8A35-F6F5-069B-3B7A6E41C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6BE07E-8C2B-9872-24D8-1D57B6E1C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99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42685-8C49-79CA-BAE7-CCFF19709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A38904-1ADA-AFDE-6746-E63B1E4801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6DA491-9E16-AA32-AED8-E5E715733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736DA6-C382-7D49-F38E-2BA1700E8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1364-6189-BE7C-0D1C-664E160FE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76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B63CE9-3FED-7E89-CD64-BA68196779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7DED29-E709-E3AD-4D02-5E7E20AE4E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73AEB-C009-0B0D-21ED-A677981E4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AE8102-0007-99C6-B261-57660FF4C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56D39-964F-2F7C-3645-5FA627ADA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29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4F6619-C077-8D1F-C0ED-9C2651539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239A61-92F0-F630-01DB-098DE7A1D7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75FCDF-5B51-723B-3101-DDB344505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C8EA61-A0DD-5DE6-6944-A7728B152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B771E-79DA-5312-D14F-88E416602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131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F00B3A-5063-42D5-2EA9-E4D613619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860D9D-D6E1-92F8-037F-69B654D6F0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A50CD-7A35-57D7-DB28-6A0DE16C0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80BBD-3B46-BCE2-73AA-5E54E99E3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08B09-63C6-1EBA-D4C4-96E9D50ED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786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075F07-23C6-C3B4-F48D-7A9C64F91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3E7409-CCEC-2762-AD3C-4D7CF2FDA0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3901AE-C209-AB8C-EA65-98838C8DC9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58BF70-1852-ADF8-4012-E128B184D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D0DFEA-417D-A5E9-A02B-B13F30630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A92A1F-8468-A7CB-CF43-EE780CECD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553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073305-554C-AA63-9053-8D628A44F1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A7A4BF-DB0F-E982-A52D-7E26298F3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89C20F-0222-5122-FC50-14D96B0C1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63EBF8-8AAF-5B4D-63A4-1DA87F3607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9341A9-B57C-2A50-CC46-2C9ECD4E7A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593A54-425C-45FE-B69F-E88DE6D7A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F21D6D-20C2-6E49-FD83-7149944A8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F0EBC1-D70B-88C7-0D58-08DCF3F26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71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E949A-132A-EF63-211B-981A277D39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E863EE-DD1F-DB12-DA07-23D30D166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37291B-8F20-0BB0-D442-EF1D73DA8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38922B-82B6-D1AF-18B3-9435A0032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839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654D2B-25D7-A6F3-F3E6-E8B5C5194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2F69C54-D7DE-8F84-255A-3DC569E9A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C8AE375-667E-C396-C807-AC810CE5F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27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84522D-58EE-DF6B-71E2-E363B08AC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A1B8F-4EA7-4BD4-E1D4-64DBBDCF77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8A414C-BC1C-3EE6-85C2-3D43D16A71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B4458-B518-A3B2-9834-8E1131625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480B0F-F269-A22E-0DAC-AC411CA3F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D3CF36-6820-46F8-63BE-FC9FA0B97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782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0348A-B0E5-80EA-C0F6-899D4D5BD1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A3A265-69A8-19CD-4D22-FD74B6D031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F87866-0E86-8CBA-844A-5D45F5F21A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22AAD0-D6F3-1329-4352-CAA2B95DC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B589D9-E0E2-411E-180A-F0AFCEB74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6A5A49-EEF3-A57B-50DE-8807FC8F2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41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B95297-A982-1CB3-1C1A-C7C82018A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14A836-7FE9-0909-486E-BA8C802D41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2C714D-91B6-1B11-73CE-364F14EC7E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9FF5F5-C7ED-794B-8579-6DAF7F323A8C}" type="datetimeFigureOut">
              <a:rPr lang="en-US" smtClean="0"/>
              <a:t>2025-10-17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34F54-8401-C9EF-E92F-31881585B5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F2CEBE-0602-4534-CB55-8F5F2A2193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B2EEBC6-456E-204B-8D7E-BC17EA918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353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omputer&#10;&#10;AI-generated content may be incorrect.">
            <a:extLst>
              <a:ext uri="{FF2B5EF4-FFF2-40B4-BE49-F238E27FC236}">
                <a16:creationId xmlns:a16="http://schemas.microsoft.com/office/drawing/2014/main" id="{5A37BD48-152D-2DF2-8E1F-D43026443B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4200" y="243161"/>
            <a:ext cx="5943600" cy="492125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90758B3-9DEE-CCE9-27FE-48AED82395AD}"/>
              </a:ext>
            </a:extLst>
          </p:cNvPr>
          <p:cNvSpPr txBox="1"/>
          <p:nvPr/>
        </p:nvSpPr>
        <p:spPr>
          <a:xfrm>
            <a:off x="1329559" y="5444359"/>
            <a:ext cx="9532882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/>
              <a:t>Figure S5</a:t>
            </a:r>
            <a:r>
              <a:rPr lang="en-US" sz="900" dirty="0"/>
              <a:t>. High-throughput co-cultivation assay on a </a:t>
            </a:r>
            <a:r>
              <a:rPr lang="en-US" sz="900" dirty="0" err="1"/>
              <a:t>QTray</a:t>
            </a:r>
            <a:r>
              <a:rPr lang="en-US" sz="900" dirty="0"/>
              <a:t> after 96 h. The top table displays the isolates in each of the 12 sets, located on the right side of each co-cultivation pair. Panes on the sides indicate the common co-cultivation partner on the left side of each co-cultivation pair in the respective set (3 rows), which includes isolates, </a:t>
            </a:r>
            <a:r>
              <a:rPr lang="en-US" sz="900" i="1" dirty="0"/>
              <a:t>S. haemolyticus </a:t>
            </a:r>
            <a:r>
              <a:rPr lang="en-US" sz="900" dirty="0"/>
              <a:t>(</a:t>
            </a:r>
            <a:r>
              <a:rPr lang="en-US" sz="900" i="1" dirty="0"/>
              <a:t>S. </a:t>
            </a:r>
            <a:r>
              <a:rPr lang="en-US" sz="900" i="1" dirty="0" err="1"/>
              <a:t>hae</a:t>
            </a:r>
            <a:r>
              <a:rPr lang="en-US" sz="900" dirty="0"/>
              <a:t>.), and </a:t>
            </a:r>
            <a:r>
              <a:rPr lang="en-US" sz="900" i="1" dirty="0"/>
              <a:t>S. agalactiae </a:t>
            </a:r>
            <a:r>
              <a:rPr lang="en-US" sz="900" dirty="0"/>
              <a:t>(</a:t>
            </a:r>
            <a:r>
              <a:rPr lang="en-US" sz="900" i="1" dirty="0"/>
              <a:t>S. aga.</a:t>
            </a:r>
            <a:r>
              <a:rPr lang="en-US" sz="900" dirty="0"/>
              <a:t>). Colored boxes on the </a:t>
            </a:r>
            <a:r>
              <a:rPr lang="en-US" sz="900" dirty="0" err="1"/>
              <a:t>QTray</a:t>
            </a:r>
            <a:r>
              <a:rPr lang="en-US" sz="900" dirty="0"/>
              <a:t> highlight combinations where both co-cultivation partners originate from the same host, as indicated in the color legend. The bottom right reference set has no co-cultivation partner, featuring two additional reference colonies of </a:t>
            </a:r>
            <a:r>
              <a:rPr lang="en-US" sz="900" i="1" dirty="0"/>
              <a:t>S. agalactiae </a:t>
            </a:r>
            <a:r>
              <a:rPr lang="en-US" sz="900" dirty="0"/>
              <a:t>and </a:t>
            </a:r>
            <a:r>
              <a:rPr lang="en-US" sz="900" i="1" dirty="0"/>
              <a:t>S. haemolyticus</a:t>
            </a:r>
            <a:r>
              <a:rPr lang="en-US" sz="900" dirty="0"/>
              <a:t>.</a:t>
            </a:r>
          </a:p>
          <a:p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636904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sea Masaki</dc:creator>
  <cp:lastModifiedBy>MDPI</cp:lastModifiedBy>
  <cp:revision>2</cp:revision>
  <dcterms:created xsi:type="dcterms:W3CDTF">2025-09-25T11:30:03Z</dcterms:created>
  <dcterms:modified xsi:type="dcterms:W3CDTF">2025-10-17T14:34:44Z</dcterms:modified>
</cp:coreProperties>
</file>